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0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DBAF1B-8278-4964-8818-C3796EA16070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U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DF3BBB-7FD9-4036-AE15-C233E8AF1C6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27071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007C9F0-1F61-774D-94B6-6FF3E6E299B5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445859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7298DA-4F9D-FAB2-55BD-C269AC24484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65E7CA-9FFA-51F4-B1C5-7214D878AB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F958F-B6D1-9A72-E9BA-9E9B5B9934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C9A2D0-29B0-5F3A-486A-02CCCD149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23E381-EB1E-8E1F-FAB5-3ECC6A8EB1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53124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808E3-A445-6A11-4982-806D4762CB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6A17FA-3F31-FEF1-E659-2FC177F38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05B808-7EE6-79D1-4EC6-48CB7E36C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BFB91E-9783-71B5-5334-D92E19A06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14E817-30B4-520C-1690-086E8F360C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10897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A0F1D4-5775-1B04-CFFC-C7F2950BA21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6BDC13-DC96-76A1-BA85-92774A449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8E3F4A-5D4A-82F6-B088-76774B126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982726-B54D-C789-9EB6-315260C153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61A568-59BC-DE07-B3CA-DF0329F21D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34164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A930CB-4AE0-032A-5692-D81CA12F27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A7FABA-8B01-B134-9CF9-4E26B88286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3D0B9D-3798-7D50-9702-AAEA4AC7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55ADFA-856E-E343-89AC-7D88E015E3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23788B-D56B-0304-8079-8D1AB6C5E6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01077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639C7D-F2D6-A4E0-A0D8-583061111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B438E-7CEF-E9C3-60D9-B9D0999CD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AF4D46-8B70-35E8-07AB-DC394C35AA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7C3931-F308-55A0-1B60-0AD15111DC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45DCF-EFA4-37E3-991F-0159E67C72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34736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741EBB-D829-0E9D-8A37-888BBB2007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3CC76F3-0F10-5DFA-B62C-939F1BD20B1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333A63-9B12-2DEB-2CE1-1AE3547EADB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9F5DEF-57A7-FA35-0DE6-487FB35141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FA21536-D74D-842D-621A-5DD1AF3FB1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E2F49F-45E9-DA7D-E967-A5E00E62E9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725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3EFBBF-F17F-12F4-E4C1-088DE060A2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C752EF-2A68-01E3-61A8-94BA0FEBD9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B877A6D-E365-ADAC-1A07-B82768F68D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3654B6-6CFE-61B2-3A16-AD648BBBC5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15FC14-2C18-1DD9-9060-5FB267AF9F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F1FB786-0028-A983-B6CE-5EE067E5DF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0582CD-B2E0-CBFC-BBE2-19EA86655D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5B00D54-0235-9CF2-1A29-9FD01E7F0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3841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6369CD-4D23-8BFC-A542-2B92D890B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DD21CBA-51F0-88AD-F604-832CE87D0F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ECD55CA-98E7-46CF-7AB4-AFABA0973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2784CE-83CC-2EAC-9FEB-ACC3B17B79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00137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040D52-7C1E-AB1D-798F-8BAE652C98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FFA8C7-33F2-02E5-7D2A-C0D1D7722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02132B-E01A-6E46-F0F2-9273B9525F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8927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1D4B46-A811-C07C-A508-0DF86A2E81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4E3D39-C1C6-B4B2-94B5-E3AD251DAB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25304D2-5DEA-1878-EA86-1275E25F19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E57E76-31E0-7F8D-E1F8-C0DAF968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6A111-82FD-9CDC-74BA-FBE7EE29F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1F2276-3ABC-51F8-BAED-E0F6F46D1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3459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8B00F-6894-5048-42F0-6537E501A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E7382-68F0-8ADD-E54A-F075972BDA8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F7FB87C-D120-E599-35B8-DC76CD239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E7358D-B640-B4AE-D58C-6E698B0706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29F8AA-1B45-7650-EE90-858F206DB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B9F684-B59A-4A16-4297-6850B3B0A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24482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0F27173-DD36-2C49-9885-E5F44228A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93987A0-A5C9-B390-BE4B-D4F17764E4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9FF9C0-7219-1D1E-A1D4-A43C84BD675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A98C1-85C1-4E34-93F7-72F715ECCB81}" type="datetimeFigureOut">
              <a:rPr lang="en-AU" smtClean="0"/>
              <a:t>5/0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E0F85-0C1B-BA21-BF4A-39B26F1240D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91B6E6-E829-B6B3-FBEE-083D5C9CC2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4550DB-18E7-40FE-B139-DCF0CDAA4DD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9029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1AF511CA-F52C-6341-B1AF-6528A3EEEA5F}"/>
              </a:ext>
            </a:extLst>
          </p:cNvPr>
          <p:cNvGrpSpPr/>
          <p:nvPr/>
        </p:nvGrpSpPr>
        <p:grpSpPr>
          <a:xfrm>
            <a:off x="459199" y="1182029"/>
            <a:ext cx="11472606" cy="4772722"/>
            <a:chOff x="1524000" y="2512770"/>
            <a:chExt cx="8952876" cy="2901396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3E9A114-4428-35CA-AEEC-C3E03D8F0D91}"/>
                </a:ext>
              </a:extLst>
            </p:cNvPr>
            <p:cNvSpPr txBox="1"/>
            <p:nvPr/>
          </p:nvSpPr>
          <p:spPr>
            <a:xfrm>
              <a:off x="2769364" y="2857583"/>
              <a:ext cx="244328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4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rPr>
                <a:t>Light Sensor (500-650nm)</a:t>
              </a:r>
              <a:endParaRPr kumimoji="0" lang="en-US" sz="1400" b="0" i="1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pic>
          <p:nvPicPr>
            <p:cNvPr id="14" name="Picture 13" descr="A picture containing text, indoor&#10;&#10;Description automatically generated">
              <a:extLst>
                <a:ext uri="{FF2B5EF4-FFF2-40B4-BE49-F238E27FC236}">
                  <a16:creationId xmlns:a16="http://schemas.microsoft.com/office/drawing/2014/main" id="{C7852577-D348-FC7B-7A8E-475889C1EA9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55" b="27778"/>
            <a:stretch/>
          </p:blipFill>
          <p:spPr>
            <a:xfrm>
              <a:off x="1524000" y="2512770"/>
              <a:ext cx="8952876" cy="2901396"/>
            </a:xfrm>
            <a:prstGeom prst="rect">
              <a:avLst/>
            </a:prstGeom>
          </p:spPr>
        </p:pic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C62DA40B-7CAC-B23D-293B-AE7F0233D87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279322" y="4319250"/>
              <a:ext cx="638405" cy="397284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6CC2835-DA4A-1C50-F45B-B8907DB7D7E3}"/>
                </a:ext>
              </a:extLst>
            </p:cNvPr>
            <p:cNvSpPr txBox="1"/>
            <p:nvPr/>
          </p:nvSpPr>
          <p:spPr>
            <a:xfrm>
              <a:off x="6701208" y="4687946"/>
              <a:ext cx="2110514" cy="16839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Light Sensor</a:t>
              </a:r>
            </a:p>
          </p:txBody>
        </p: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D25293CD-3A83-53D0-EB1E-8A76751515E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228812" y="3959819"/>
              <a:ext cx="50509" cy="180746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70C293C-7C43-7B4F-8E71-517A53A13CFF}"/>
                </a:ext>
              </a:extLst>
            </p:cNvPr>
            <p:cNvSpPr txBox="1"/>
            <p:nvPr/>
          </p:nvSpPr>
          <p:spPr>
            <a:xfrm>
              <a:off x="6072881" y="3794535"/>
              <a:ext cx="538152" cy="168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Balloon</a:t>
              </a:r>
            </a:p>
          </p:txBody>
        </p: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6547E06A-37D5-AB1C-EEC9-92ACF59E4DF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803654" y="4345231"/>
              <a:ext cx="735429" cy="371303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A66F1BC-0973-A883-6582-D4C7BD745D92}"/>
                </a:ext>
              </a:extLst>
            </p:cNvPr>
            <p:cNvSpPr txBox="1"/>
            <p:nvPr/>
          </p:nvSpPr>
          <p:spPr>
            <a:xfrm>
              <a:off x="4533343" y="4690618"/>
              <a:ext cx="771176" cy="168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Fibre Optic </a:t>
              </a:r>
            </a:p>
          </p:txBody>
        </p: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AAE1A36D-7089-9718-A56E-F08DAC50637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8348364" y="3468622"/>
              <a:ext cx="771670" cy="217848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212301BE-123E-3A49-89E8-4F8F99E3069E}"/>
                </a:ext>
              </a:extLst>
            </p:cNvPr>
            <p:cNvSpPr txBox="1"/>
            <p:nvPr/>
          </p:nvSpPr>
          <p:spPr>
            <a:xfrm>
              <a:off x="7912737" y="3697100"/>
              <a:ext cx="1262435" cy="2806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Portable UV Light Source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989AFCE4-67AE-7FEB-4248-9643873CCF45}"/>
                </a:ext>
              </a:extLst>
            </p:cNvPr>
            <p:cNvSpPr txBox="1"/>
            <p:nvPr/>
          </p:nvSpPr>
          <p:spPr>
            <a:xfrm>
              <a:off x="1766645" y="4319250"/>
              <a:ext cx="1143014" cy="2806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Light Sensor Display</a:t>
              </a:r>
            </a:p>
          </p:txBody>
        </p: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412F4AC6-012F-3F28-D4BF-DC6FD9A456E8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7057678" y="3959819"/>
              <a:ext cx="474505" cy="290274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501CF4ED-3FAD-7BAF-F2C9-F58E3EE413D9}"/>
                </a:ext>
              </a:extLst>
            </p:cNvPr>
            <p:cNvSpPr txBox="1"/>
            <p:nvPr/>
          </p:nvSpPr>
          <p:spPr>
            <a:xfrm>
              <a:off x="7433078" y="4248654"/>
              <a:ext cx="358018" cy="1683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AU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rPr>
                <a:t>GW</a:t>
              </a:r>
            </a:p>
          </p:txBody>
        </p: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FBF686DE-7587-2C45-A9B0-C40E3E71615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384879" y="4032138"/>
              <a:ext cx="384485" cy="322356"/>
            </a:xfrm>
            <a:prstGeom prst="straightConnector1">
              <a:avLst/>
            </a:prstGeom>
            <a:ln w="190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Title 8">
            <a:extLst>
              <a:ext uri="{FF2B5EF4-FFF2-40B4-BE49-F238E27FC236}">
                <a16:creationId xmlns:a16="http://schemas.microsoft.com/office/drawing/2014/main" id="{530BED04-8856-EB4A-9780-667209C96A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964029F-46EF-1D4B-8090-03F176E54C56}"/>
              </a:ext>
            </a:extLst>
          </p:cNvPr>
          <p:cNvSpPr txBox="1"/>
          <p:nvPr/>
        </p:nvSpPr>
        <p:spPr>
          <a:xfrm>
            <a:off x="3911494" y="324783"/>
            <a:ext cx="39428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AU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Online Resource 3a</a:t>
            </a:r>
          </a:p>
        </p:txBody>
      </p:sp>
    </p:spTree>
    <p:extLst>
      <p:ext uri="{BB962C8B-B14F-4D97-AF65-F5344CB8AC3E}">
        <p14:creationId xmlns:p14="http://schemas.microsoft.com/office/powerpoint/2010/main" val="1299338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23</Words>
  <Application>Microsoft Office PowerPoint</Application>
  <PresentationFormat>Widescreen</PresentationFormat>
  <Paragraphs>1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 </vt:lpstr>
    </vt:vector>
  </TitlesOfParts>
  <Company>Monas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hony Dear</dc:creator>
  <cp:lastModifiedBy>Anthony Dear</cp:lastModifiedBy>
  <cp:revision>3</cp:revision>
  <dcterms:created xsi:type="dcterms:W3CDTF">2023-01-04T23:35:19Z</dcterms:created>
  <dcterms:modified xsi:type="dcterms:W3CDTF">2023-01-05T00:20:52Z</dcterms:modified>
</cp:coreProperties>
</file>